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2A2CB7-BA9F-429F-8D4D-CA3776D73B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20DD6-FD05-43C3-B399-687CB0FA13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E4FBC-18E7-44D4-A4E2-26AB218ADA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149FD-D301-4702-9C22-C269F38CB3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42017-7D29-4AC8-814C-A01C3C480F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9970C8-FAF7-43B9-A196-8EF5F4D23C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A4A88A-B12D-48B7-AED4-5211EA7CDA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131EE-CD84-4860-9E13-1D98A950D9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633E7-A1D7-4CC0-869F-9422BDBFE6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307F27-C5EB-41A9-8F57-CE982063CF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5EA9D-F63F-4118-AC90-DDC7CB64DD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778834-B9E8-4888-899B-616924ECB6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5B3B62-AA0B-4492-9722-2DFC5DF8065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>
            <a:lum bright="12000"/>
          </a:blip>
          <a:stretch/>
        </p:blipFill>
        <p:spPr>
          <a:xfrm>
            <a:off x="2133720" y="2755800"/>
            <a:ext cx="5029200" cy="2923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>
            <a:lum bright="12000"/>
          </a:blip>
          <a:stretch/>
        </p:blipFill>
        <p:spPr>
          <a:xfrm>
            <a:off x="2133720" y="2362320"/>
            <a:ext cx="5029200" cy="314280"/>
          </a:xfrm>
          <a:prstGeom prst="rect">
            <a:avLst/>
          </a:prstGeom>
          <a:ln w="0">
            <a:noFill/>
          </a:ln>
        </p:spPr>
      </p:pic>
      <p:sp>
        <p:nvSpPr>
          <p:cNvPr id="43" name="TextBox 152"/>
          <p:cNvSpPr/>
          <p:nvPr/>
        </p:nvSpPr>
        <p:spPr>
          <a:xfrm>
            <a:off x="5716800" y="1922400"/>
            <a:ext cx="427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00"/>
                </a:solidFill>
                <a:latin typeface="Arial"/>
                <a:ea typeface="Arial"/>
              </a:rPr>
              <a:t>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137"/>
          <p:cNvSpPr/>
          <p:nvPr/>
        </p:nvSpPr>
        <p:spPr>
          <a:xfrm>
            <a:off x="3278880" y="1905120"/>
            <a:ext cx="43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33"/>
          <p:cNvSpPr/>
          <p:nvPr/>
        </p:nvSpPr>
        <p:spPr>
          <a:xfrm>
            <a:off x="1380240" y="2392200"/>
            <a:ext cx="67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ldh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33"/>
          <p:cNvSpPr/>
          <p:nvPr/>
        </p:nvSpPr>
        <p:spPr>
          <a:xfrm>
            <a:off x="1311120" y="2743200"/>
            <a:ext cx="822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ubul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39"/>
          <p:cNvSpPr/>
          <p:nvPr/>
        </p:nvSpPr>
        <p:spPr>
          <a:xfrm>
            <a:off x="5715000" y="3124080"/>
            <a:ext cx="38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40"/>
          <p:cNvSpPr/>
          <p:nvPr/>
        </p:nvSpPr>
        <p:spPr>
          <a:xfrm>
            <a:off x="6400800" y="312408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BH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39"/>
          <p:cNvSpPr/>
          <p:nvPr/>
        </p:nvSpPr>
        <p:spPr>
          <a:xfrm>
            <a:off x="4724280" y="312408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39"/>
          <p:cNvSpPr/>
          <p:nvPr/>
        </p:nvSpPr>
        <p:spPr>
          <a:xfrm>
            <a:off x="3276720" y="3124080"/>
            <a:ext cx="38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40"/>
          <p:cNvSpPr/>
          <p:nvPr/>
        </p:nvSpPr>
        <p:spPr>
          <a:xfrm>
            <a:off x="3962520" y="312408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BH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39"/>
          <p:cNvSpPr/>
          <p:nvPr/>
        </p:nvSpPr>
        <p:spPr>
          <a:xfrm>
            <a:off x="2286000" y="312408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800600" y="2247840"/>
            <a:ext cx="2286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57200" y="4191120"/>
            <a:ext cx="822960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6. Differential expression of Aldh2 at baseline and following activation of Nrf2 pathway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dh2 expression was not affected by 8 h treatment with 5 μM SF or 10 μM tBHQ in either cell type; regardless of the treatment, Aldh2 expression level was significantly lower in CRI-G1-RS than in CRI-G1-RR cells. Aldh2 protein level (apparent MW, 51 kDa) was determined in cytoplasmic fractions with tubulin (apparent MW, 51 kDa) as a loading control; corresponding nuclear fractions were used to measure Nrf2 levels in Fig. 6. A representative of &gt; 3 repeat experiments is shown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286000" y="2247840"/>
            <a:ext cx="2286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7T17:23:27Z</dcterms:created>
  <dc:creator>SysAdmin</dc:creator>
  <dc:description/>
  <dc:language>en-US</dc:language>
  <cp:lastModifiedBy>Marta Margeta</cp:lastModifiedBy>
  <dcterms:modified xsi:type="dcterms:W3CDTF">2010-07-14T01:39:14Z</dcterms:modified>
  <cp:revision>8</cp:revision>
  <dc:subject/>
  <dc:title>Slide 1</dc:title>
</cp:coreProperties>
</file>